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906000" cy="6858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774" y="-253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32CD2-DD7B-4DC1-8E0A-F5DBD9D3A784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94BD12-10A2-4009-B836-496B023E8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5842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67036C-2891-4725-8B47-49EB25A4C6B0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787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67036C-2891-4725-8B47-49EB25A4C6B0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49649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67036C-2891-4725-8B47-49EB25A4C6B0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245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0078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4265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0198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8650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1025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4814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9730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9844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5301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588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481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74F86-DA74-411D-8A16-747885F6C550}" type="datetimeFigureOut">
              <a:rPr lang="ko-KR" altLang="en-US" smtClean="0"/>
              <a:t>2016-0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925576-2DB6-4FF1-A35B-10B18FD4C79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097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901421"/>
            <a:ext cx="2013606" cy="16946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0745" y="2755827"/>
            <a:ext cx="1969349" cy="16907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0"/>
          <a:stretch/>
        </p:blipFill>
        <p:spPr bwMode="auto">
          <a:xfrm>
            <a:off x="19227" y="2761688"/>
            <a:ext cx="1947716" cy="1676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"/>
          <a:stretch/>
        </p:blipFill>
        <p:spPr bwMode="auto">
          <a:xfrm>
            <a:off x="19227" y="676530"/>
            <a:ext cx="1966260" cy="16345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6354" y="700288"/>
            <a:ext cx="1993499" cy="1617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116463" y="269032"/>
            <a:ext cx="95950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1. </a:t>
            </a:r>
            <a:endParaRPr lang="ko-KR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0" y="538321"/>
            <a:ext cx="350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A</a:t>
            </a:r>
            <a:endParaRPr lang="ko-KR" alt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19227" y="2564904"/>
            <a:ext cx="350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2551" y="683196"/>
            <a:ext cx="1967543" cy="16345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0094" y="671320"/>
            <a:ext cx="2015160" cy="16437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4081" y="2756163"/>
            <a:ext cx="2008549" cy="16903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0094" y="2733096"/>
            <a:ext cx="2025906" cy="17050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19227" y="4653136"/>
            <a:ext cx="350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</a:t>
            </a:r>
            <a:endParaRPr lang="ko-KR" altLang="en-US" b="1" dirty="0"/>
          </a:p>
        </p:txBody>
      </p:sp>
      <p:pic>
        <p:nvPicPr>
          <p:cNvPr id="3" name="Picture 6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90840" y="4870088"/>
            <a:ext cx="2015160" cy="16959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6792" y="697109"/>
            <a:ext cx="1960652" cy="1633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6354" y="2761688"/>
            <a:ext cx="2021183" cy="17001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8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9443" y="4899378"/>
            <a:ext cx="2015003" cy="1695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10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8115" y="4911677"/>
            <a:ext cx="1989231" cy="1674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9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7783" y="4954794"/>
            <a:ext cx="1964847" cy="1641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61072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94471" y="188641"/>
            <a:ext cx="971152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he relationship among the ERBB family 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RTK expression in TNBC  </a:t>
            </a:r>
            <a:endParaRPr lang="ko-KR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2555" y="1268760"/>
            <a:ext cx="6449219" cy="5257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032291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25775" y="4362663"/>
            <a:ext cx="3978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Log Rank P-value : .029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94471" y="269032"/>
            <a:ext cx="60846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(A) Early sta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109017" y="4362663"/>
            <a:ext cx="3978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Log Rank P-value : .20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538670" y="269032"/>
            <a:ext cx="3978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Advanced sta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5155640" y="5029724"/>
            <a:ext cx="4524503" cy="1077218"/>
            <a:chOff x="4759052" y="5029724"/>
            <a:chExt cx="4176464" cy="1077218"/>
          </a:xfrm>
        </p:grpSpPr>
        <p:cxnSp>
          <p:nvCxnSpPr>
            <p:cNvPr id="8" name="직선 연결선 7"/>
            <p:cNvCxnSpPr/>
            <p:nvPr/>
          </p:nvCxnSpPr>
          <p:spPr>
            <a:xfrm>
              <a:off x="4759052" y="5197676"/>
              <a:ext cx="1368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연결선 10"/>
            <p:cNvCxnSpPr/>
            <p:nvPr/>
          </p:nvCxnSpPr>
          <p:spPr>
            <a:xfrm>
              <a:off x="4785532" y="5480447"/>
              <a:ext cx="1368152" cy="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6271220" y="5029724"/>
              <a:ext cx="2664296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BB4 Low  ESR1 Low</a:t>
              </a:r>
            </a:p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BB4 High ESR1 Low</a:t>
              </a:r>
            </a:p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BB4 Low  ESR1 High</a:t>
              </a:r>
            </a:p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BB4 High ESR1 High</a:t>
              </a:r>
            </a:p>
          </p:txBody>
        </p:sp>
        <p:cxnSp>
          <p:nvCxnSpPr>
            <p:cNvPr id="14" name="직선 연결선 13"/>
            <p:cNvCxnSpPr/>
            <p:nvPr/>
          </p:nvCxnSpPr>
          <p:spPr>
            <a:xfrm>
              <a:off x="4785532" y="5733256"/>
              <a:ext cx="1368152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연결선 14"/>
            <p:cNvCxnSpPr/>
            <p:nvPr/>
          </p:nvCxnSpPr>
          <p:spPr>
            <a:xfrm>
              <a:off x="4768577" y="5962900"/>
              <a:ext cx="1368152" cy="0"/>
            </a:xfrm>
            <a:prstGeom prst="line">
              <a:avLst/>
            </a:prstGeom>
            <a:ln w="19050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496" y="908721"/>
            <a:ext cx="4309186" cy="3347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0535" y="908721"/>
            <a:ext cx="4312942" cy="34539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42305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62</Words>
  <Application>Microsoft Office PowerPoint</Application>
  <PresentationFormat>A4 용지(210x297mm)</PresentationFormat>
  <Paragraphs>16</Paragraphs>
  <Slides>3</Slides>
  <Notes>3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M500T4A</dc:creator>
  <cp:lastModifiedBy>KJY</cp:lastModifiedBy>
  <cp:revision>15</cp:revision>
  <dcterms:created xsi:type="dcterms:W3CDTF">2015-08-25T13:20:58Z</dcterms:created>
  <dcterms:modified xsi:type="dcterms:W3CDTF">2016-02-01T12:27:38Z</dcterms:modified>
</cp:coreProperties>
</file>